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72" d="100"/>
          <a:sy n="72" d="100"/>
        </p:scale>
        <p:origin x="552" y="54"/>
      </p:cViewPr>
      <p:guideLst>
        <p:guide orient="horz" pos="2183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15A4F-284F-4AE3-9EAB-79C2A103B78E}" type="datetimeFigureOut">
              <a:rPr lang="zh-CN" altLang="en-US" smtClean="0"/>
              <a:t>2018/10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93398-AA20-4204-A76E-DF6A77DE96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80617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15A4F-284F-4AE3-9EAB-79C2A103B78E}" type="datetimeFigureOut">
              <a:rPr lang="zh-CN" altLang="en-US" smtClean="0"/>
              <a:t>2018/10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93398-AA20-4204-A76E-DF6A77DE96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52206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15A4F-284F-4AE3-9EAB-79C2A103B78E}" type="datetimeFigureOut">
              <a:rPr lang="zh-CN" altLang="en-US" smtClean="0"/>
              <a:t>2018/10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93398-AA20-4204-A76E-DF6A77DE96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36673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15A4F-284F-4AE3-9EAB-79C2A103B78E}" type="datetimeFigureOut">
              <a:rPr lang="zh-CN" altLang="en-US" smtClean="0"/>
              <a:t>2018/10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93398-AA20-4204-A76E-DF6A77DE96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46814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15A4F-284F-4AE3-9EAB-79C2A103B78E}" type="datetimeFigureOut">
              <a:rPr lang="zh-CN" altLang="en-US" smtClean="0"/>
              <a:t>2018/10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93398-AA20-4204-A76E-DF6A77DE96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84552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15A4F-284F-4AE3-9EAB-79C2A103B78E}" type="datetimeFigureOut">
              <a:rPr lang="zh-CN" altLang="en-US" smtClean="0"/>
              <a:t>2018/10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93398-AA20-4204-A76E-DF6A77DE96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08065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15A4F-284F-4AE3-9EAB-79C2A103B78E}" type="datetimeFigureOut">
              <a:rPr lang="zh-CN" altLang="en-US" smtClean="0"/>
              <a:t>2018/10/1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93398-AA20-4204-A76E-DF6A77DE96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27979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15A4F-284F-4AE3-9EAB-79C2A103B78E}" type="datetimeFigureOut">
              <a:rPr lang="zh-CN" altLang="en-US" smtClean="0"/>
              <a:t>2018/10/1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93398-AA20-4204-A76E-DF6A77DE96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28914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15A4F-284F-4AE3-9EAB-79C2A103B78E}" type="datetimeFigureOut">
              <a:rPr lang="zh-CN" altLang="en-US" smtClean="0"/>
              <a:t>2018/10/1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93398-AA20-4204-A76E-DF6A77DE96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08101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15A4F-284F-4AE3-9EAB-79C2A103B78E}" type="datetimeFigureOut">
              <a:rPr lang="zh-CN" altLang="en-US" smtClean="0"/>
              <a:t>2018/10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93398-AA20-4204-A76E-DF6A77DE96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11763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15A4F-284F-4AE3-9EAB-79C2A103B78E}" type="datetimeFigureOut">
              <a:rPr lang="zh-CN" altLang="en-US" smtClean="0"/>
              <a:t>2018/10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93398-AA20-4204-A76E-DF6A77DE96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08930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15A4F-284F-4AE3-9EAB-79C2A103B78E}" type="datetimeFigureOut">
              <a:rPr lang="zh-CN" altLang="en-US" smtClean="0"/>
              <a:t>2018/10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393398-AA20-4204-A76E-DF6A77DE96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0114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1442963" y="4549676"/>
            <a:ext cx="10277982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Body weight, 24-hour food intake and serum lipids levels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Body weight in each week, </a:t>
            </a:r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an±SD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(b)24-hour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ood intake in each week, </a:t>
            </a:r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an±SEM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(c)Serum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riglyceride concentration, </a:t>
            </a:r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an±SD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(d)Serum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otal cholesterol, </a:t>
            </a:r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an±SD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. n=5-10.####</a:t>
            </a:r>
            <a:r>
              <a:rPr lang="en-US" altLang="zh-CN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&lt;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0.0001 vs control group. 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7452" y="171720"/>
            <a:ext cx="5083939" cy="43779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958765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57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Calibri Light</vt:lpstr>
      <vt:lpstr>Office 主题</vt:lpstr>
      <vt:lpstr>PowerPoint 演示文稿</vt:lpstr>
    </vt:vector>
  </TitlesOfParts>
  <Company>chin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istrator</cp:lastModifiedBy>
  <cp:revision>9</cp:revision>
  <dcterms:created xsi:type="dcterms:W3CDTF">2018-09-19T01:02:03Z</dcterms:created>
  <dcterms:modified xsi:type="dcterms:W3CDTF">2018-10-11T06:44:43Z</dcterms:modified>
</cp:coreProperties>
</file>